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E3D9-6008-4037-9E58-94424AC33E7F}" type="datetimeFigureOut">
              <a:rPr lang="ko-KR" altLang="en-US" smtClean="0"/>
              <a:t>2023-06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B1705-D69F-495A-9AA9-ED85C84447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916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E3D9-6008-4037-9E58-94424AC33E7F}" type="datetimeFigureOut">
              <a:rPr lang="ko-KR" altLang="en-US" smtClean="0"/>
              <a:t>2023-06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B1705-D69F-495A-9AA9-ED85C84447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0899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E3D9-6008-4037-9E58-94424AC33E7F}" type="datetimeFigureOut">
              <a:rPr lang="ko-KR" altLang="en-US" smtClean="0"/>
              <a:t>2023-06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B1705-D69F-495A-9AA9-ED85C84447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8513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E3D9-6008-4037-9E58-94424AC33E7F}" type="datetimeFigureOut">
              <a:rPr lang="ko-KR" altLang="en-US" smtClean="0"/>
              <a:t>2023-06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B1705-D69F-495A-9AA9-ED85C84447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9587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E3D9-6008-4037-9E58-94424AC33E7F}" type="datetimeFigureOut">
              <a:rPr lang="ko-KR" altLang="en-US" smtClean="0"/>
              <a:t>2023-06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B1705-D69F-495A-9AA9-ED85C84447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1977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E3D9-6008-4037-9E58-94424AC33E7F}" type="datetimeFigureOut">
              <a:rPr lang="ko-KR" altLang="en-US" smtClean="0"/>
              <a:t>2023-06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B1705-D69F-495A-9AA9-ED85C84447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9849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E3D9-6008-4037-9E58-94424AC33E7F}" type="datetimeFigureOut">
              <a:rPr lang="ko-KR" altLang="en-US" smtClean="0"/>
              <a:t>2023-06-1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B1705-D69F-495A-9AA9-ED85C84447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7640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E3D9-6008-4037-9E58-94424AC33E7F}" type="datetimeFigureOut">
              <a:rPr lang="ko-KR" altLang="en-US" smtClean="0"/>
              <a:t>2023-06-1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B1705-D69F-495A-9AA9-ED85C84447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151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E3D9-6008-4037-9E58-94424AC33E7F}" type="datetimeFigureOut">
              <a:rPr lang="ko-KR" altLang="en-US" smtClean="0"/>
              <a:t>2023-06-1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B1705-D69F-495A-9AA9-ED85C84447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7240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E3D9-6008-4037-9E58-94424AC33E7F}" type="datetimeFigureOut">
              <a:rPr lang="ko-KR" altLang="en-US" smtClean="0"/>
              <a:t>2023-06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B1705-D69F-495A-9AA9-ED85C84447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6625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E3D9-6008-4037-9E58-94424AC33E7F}" type="datetimeFigureOut">
              <a:rPr lang="ko-KR" altLang="en-US" smtClean="0"/>
              <a:t>2023-06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B1705-D69F-495A-9AA9-ED85C84447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3771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FE3D9-6008-4037-9E58-94424AC33E7F}" type="datetimeFigureOut">
              <a:rPr lang="ko-KR" altLang="en-US" smtClean="0"/>
              <a:t>2023-06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B1705-D69F-495A-9AA9-ED85C84447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7736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97582" y="2134173"/>
            <a:ext cx="5398500" cy="318600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0088" y="2134173"/>
            <a:ext cx="5398500" cy="3186000"/>
          </a:xfrm>
          <a:prstGeom prst="rect">
            <a:avLst/>
          </a:prstGeom>
        </p:spPr>
      </p:pic>
      <p:cxnSp>
        <p:nvCxnSpPr>
          <p:cNvPr id="31" name="직선 연결선 30"/>
          <p:cNvCxnSpPr/>
          <p:nvPr/>
        </p:nvCxnSpPr>
        <p:spPr>
          <a:xfrm flipV="1">
            <a:off x="980321" y="3562811"/>
            <a:ext cx="3708000" cy="35546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 flipH="1">
            <a:off x="1516999" y="3581731"/>
            <a:ext cx="15036" cy="1258116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66255" y="124691"/>
            <a:ext cx="2657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S1A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528957" y="4470515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&lt;0.001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585122" y="4988104"/>
            <a:ext cx="14282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Time (months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0800000">
            <a:off x="410756" y="2689004"/>
            <a:ext cx="430887" cy="173098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Overall survival (%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32" name="표 31"/>
          <p:cNvGraphicFramePr>
            <a:graphicFrameLocks noGrp="1"/>
          </p:cNvGraphicFramePr>
          <p:nvPr/>
        </p:nvGraphicFramePr>
        <p:xfrm>
          <a:off x="113993" y="5377022"/>
          <a:ext cx="5999326" cy="520152"/>
        </p:xfrm>
        <a:graphic>
          <a:graphicData uri="http://schemas.openxmlformats.org/drawingml/2006/table">
            <a:tbl>
              <a:tblPr/>
              <a:tblGrid>
                <a:gridCol w="757008">
                  <a:extLst>
                    <a:ext uri="{9D8B030D-6E8A-4147-A177-3AD203B41FA5}">
                      <a16:colId xmlns:a16="http://schemas.microsoft.com/office/drawing/2014/main" val="3641363282"/>
                    </a:ext>
                  </a:extLst>
                </a:gridCol>
                <a:gridCol w="791544">
                  <a:extLst>
                    <a:ext uri="{9D8B030D-6E8A-4147-A177-3AD203B41FA5}">
                      <a16:colId xmlns:a16="http://schemas.microsoft.com/office/drawing/2014/main" val="1399146309"/>
                    </a:ext>
                  </a:extLst>
                </a:gridCol>
                <a:gridCol w="798022">
                  <a:extLst>
                    <a:ext uri="{9D8B030D-6E8A-4147-A177-3AD203B41FA5}">
                      <a16:colId xmlns:a16="http://schemas.microsoft.com/office/drawing/2014/main" val="1474105335"/>
                    </a:ext>
                  </a:extLst>
                </a:gridCol>
                <a:gridCol w="756458">
                  <a:extLst>
                    <a:ext uri="{9D8B030D-6E8A-4147-A177-3AD203B41FA5}">
                      <a16:colId xmlns:a16="http://schemas.microsoft.com/office/drawing/2014/main" val="280477039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75556681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69616439"/>
                    </a:ext>
                  </a:extLst>
                </a:gridCol>
                <a:gridCol w="806335">
                  <a:extLst>
                    <a:ext uri="{9D8B030D-6E8A-4147-A177-3AD203B41FA5}">
                      <a16:colId xmlns:a16="http://schemas.microsoft.com/office/drawing/2014/main" val="3056659563"/>
                    </a:ext>
                  </a:extLst>
                </a:gridCol>
                <a:gridCol w="626919">
                  <a:extLst>
                    <a:ext uri="{9D8B030D-6E8A-4147-A177-3AD203B41FA5}">
                      <a16:colId xmlns:a16="http://schemas.microsoft.com/office/drawing/2014/main" val="3411186500"/>
                    </a:ext>
                  </a:extLst>
                </a:gridCol>
              </a:tblGrid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Surger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705597"/>
                  </a:ext>
                </a:extLst>
              </a:tr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No Surger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8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8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0191494"/>
                  </a:ext>
                </a:extLst>
              </a:tr>
            </a:tbl>
          </a:graphicData>
        </a:graphic>
      </p:graphicFrame>
      <p:cxnSp>
        <p:nvCxnSpPr>
          <p:cNvPr id="33" name="직선 연결선 32"/>
          <p:cNvCxnSpPr/>
          <p:nvPr/>
        </p:nvCxnSpPr>
        <p:spPr>
          <a:xfrm>
            <a:off x="3297610" y="2360528"/>
            <a:ext cx="46800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/>
          <p:cNvCxnSpPr/>
          <p:nvPr/>
        </p:nvCxnSpPr>
        <p:spPr>
          <a:xfrm flipV="1">
            <a:off x="3297610" y="2056747"/>
            <a:ext cx="468000" cy="52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5" name="표 34"/>
          <p:cNvGraphicFramePr>
            <a:graphicFrameLocks noGrp="1"/>
          </p:cNvGraphicFramePr>
          <p:nvPr/>
        </p:nvGraphicFramePr>
        <p:xfrm>
          <a:off x="3865069" y="1888859"/>
          <a:ext cx="205200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3500">
                  <a:extLst>
                    <a:ext uri="{9D8B030D-6E8A-4147-A177-3AD203B41FA5}">
                      <a16:colId xmlns:a16="http://schemas.microsoft.com/office/drawing/2014/main" val="4054309642"/>
                    </a:ext>
                  </a:extLst>
                </a:gridCol>
                <a:gridCol w="1168500">
                  <a:extLst>
                    <a:ext uri="{9D8B030D-6E8A-4147-A177-3AD203B41FA5}">
                      <a16:colId xmlns:a16="http://schemas.microsoft.com/office/drawing/2014/main" val="1883565153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urgery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8.7 (28.3-69.1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45897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 surgery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.0</a:t>
                      </a:r>
                      <a:r>
                        <a:rPr lang="en-US" altLang="ko-KR" sz="1200" baseline="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(6.1-7.9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1441797"/>
                  </a:ext>
                </a:extLst>
              </a:tr>
            </a:tbl>
          </a:graphicData>
        </a:graphic>
      </p:graphicFrame>
      <p:sp>
        <p:nvSpPr>
          <p:cNvPr id="36" name="TextBox 35"/>
          <p:cNvSpPr txBox="1"/>
          <p:nvPr/>
        </p:nvSpPr>
        <p:spPr>
          <a:xfrm>
            <a:off x="3865069" y="1622283"/>
            <a:ext cx="2010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Median OS, months (95% CI)</a:t>
            </a:r>
            <a:endParaRPr lang="ko-KR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865069" y="2458344"/>
            <a:ext cx="2441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HR 0.21 (95% CI 0.13-0.35; </a:t>
            </a:r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&lt;0.001)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744466" y="4988901"/>
            <a:ext cx="14282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Time (months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0800000">
            <a:off x="6539102" y="2245898"/>
            <a:ext cx="430887" cy="250934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Progression free survival (%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6" name="직선 연결선 45"/>
          <p:cNvCxnSpPr/>
          <p:nvPr/>
        </p:nvCxnSpPr>
        <p:spPr>
          <a:xfrm>
            <a:off x="7125969" y="3590045"/>
            <a:ext cx="3708000" cy="831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 flipH="1">
            <a:off x="7456378" y="3598357"/>
            <a:ext cx="13068" cy="124598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7469446" y="4466693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&lt;0.001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6" name="직선 연결선 55"/>
          <p:cNvCxnSpPr/>
          <p:nvPr/>
        </p:nvCxnSpPr>
        <p:spPr>
          <a:xfrm>
            <a:off x="9182847" y="2323098"/>
            <a:ext cx="46800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/>
          <p:cNvCxnSpPr/>
          <p:nvPr/>
        </p:nvCxnSpPr>
        <p:spPr>
          <a:xfrm flipV="1">
            <a:off x="9182847" y="2019317"/>
            <a:ext cx="468000" cy="52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8" name="표 57"/>
          <p:cNvGraphicFramePr>
            <a:graphicFrameLocks noGrp="1"/>
          </p:cNvGraphicFramePr>
          <p:nvPr/>
        </p:nvGraphicFramePr>
        <p:xfrm>
          <a:off x="9750306" y="1851429"/>
          <a:ext cx="205200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3500">
                  <a:extLst>
                    <a:ext uri="{9D8B030D-6E8A-4147-A177-3AD203B41FA5}">
                      <a16:colId xmlns:a16="http://schemas.microsoft.com/office/drawing/2014/main" val="4054309642"/>
                    </a:ext>
                  </a:extLst>
                </a:gridCol>
                <a:gridCol w="1168500">
                  <a:extLst>
                    <a:ext uri="{9D8B030D-6E8A-4147-A177-3AD203B41FA5}">
                      <a16:colId xmlns:a16="http://schemas.microsoft.com/office/drawing/2014/main" val="1883565153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urgery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8.7 (28.3-69.1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45897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 surgery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4</a:t>
                      </a:r>
                      <a:r>
                        <a:rPr lang="en-US" altLang="ko-KR" sz="1200" baseline="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(4.0-4.9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1441797"/>
                  </a:ext>
                </a:extLst>
              </a:tr>
            </a:tbl>
          </a:graphicData>
        </a:graphic>
      </p:graphicFrame>
      <p:sp>
        <p:nvSpPr>
          <p:cNvPr id="59" name="TextBox 58"/>
          <p:cNvSpPr txBox="1"/>
          <p:nvPr/>
        </p:nvSpPr>
        <p:spPr>
          <a:xfrm>
            <a:off x="9750306" y="1584853"/>
            <a:ext cx="20567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Median PFS, months (95% CI)</a:t>
            </a:r>
            <a:endParaRPr lang="ko-KR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9750306" y="2420914"/>
            <a:ext cx="2441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HR 0.22 (95% CI 0.14-0.36; </a:t>
            </a:r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&lt;0.001)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61" name="표 60"/>
          <p:cNvGraphicFramePr>
            <a:graphicFrameLocks noGrp="1"/>
          </p:cNvGraphicFramePr>
          <p:nvPr/>
        </p:nvGraphicFramePr>
        <p:xfrm>
          <a:off x="6306763" y="5375228"/>
          <a:ext cx="5876407" cy="520152"/>
        </p:xfrm>
        <a:graphic>
          <a:graphicData uri="http://schemas.openxmlformats.org/drawingml/2006/table">
            <a:tbl>
              <a:tblPr/>
              <a:tblGrid>
                <a:gridCol w="757008">
                  <a:extLst>
                    <a:ext uri="{9D8B030D-6E8A-4147-A177-3AD203B41FA5}">
                      <a16:colId xmlns:a16="http://schemas.microsoft.com/office/drawing/2014/main" val="3641363282"/>
                    </a:ext>
                  </a:extLst>
                </a:gridCol>
                <a:gridCol w="791544">
                  <a:extLst>
                    <a:ext uri="{9D8B030D-6E8A-4147-A177-3AD203B41FA5}">
                      <a16:colId xmlns:a16="http://schemas.microsoft.com/office/drawing/2014/main" val="1399146309"/>
                    </a:ext>
                  </a:extLst>
                </a:gridCol>
                <a:gridCol w="798022">
                  <a:extLst>
                    <a:ext uri="{9D8B030D-6E8A-4147-A177-3AD203B41FA5}">
                      <a16:colId xmlns:a16="http://schemas.microsoft.com/office/drawing/2014/main" val="1474105335"/>
                    </a:ext>
                  </a:extLst>
                </a:gridCol>
                <a:gridCol w="756458">
                  <a:extLst>
                    <a:ext uri="{9D8B030D-6E8A-4147-A177-3AD203B41FA5}">
                      <a16:colId xmlns:a16="http://schemas.microsoft.com/office/drawing/2014/main" val="280477039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75556681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69616439"/>
                    </a:ext>
                  </a:extLst>
                </a:gridCol>
                <a:gridCol w="806335">
                  <a:extLst>
                    <a:ext uri="{9D8B030D-6E8A-4147-A177-3AD203B41FA5}">
                      <a16:colId xmlns:a16="http://schemas.microsoft.com/office/drawing/2014/main" val="3056659563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3411186500"/>
                    </a:ext>
                  </a:extLst>
                </a:gridCol>
              </a:tblGrid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Surger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705597"/>
                  </a:ext>
                </a:extLst>
              </a:tr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No Surger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8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1" hangingPunct="1"/>
                      <a:r>
                        <a:rPr lang="en-US" altLang="ko-KR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0191494"/>
                  </a:ext>
                </a:extLst>
              </a:tr>
            </a:tbl>
          </a:graphicData>
        </a:graphic>
      </p:graphicFrame>
      <p:sp>
        <p:nvSpPr>
          <p:cNvPr id="40" name="TextBox 39"/>
          <p:cNvSpPr txBox="1"/>
          <p:nvPr/>
        </p:nvSpPr>
        <p:spPr>
          <a:xfrm>
            <a:off x="6306763" y="124691"/>
            <a:ext cx="264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S1B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9" name="직선 연결선 38"/>
          <p:cNvCxnSpPr/>
          <p:nvPr/>
        </p:nvCxnSpPr>
        <p:spPr>
          <a:xfrm flipH="1">
            <a:off x="4661976" y="3590044"/>
            <a:ext cx="15036" cy="1258116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/>
          <p:cNvCxnSpPr/>
          <p:nvPr/>
        </p:nvCxnSpPr>
        <p:spPr>
          <a:xfrm flipH="1">
            <a:off x="10805915" y="3590044"/>
            <a:ext cx="13068" cy="124598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535217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2527" y="2136360"/>
            <a:ext cx="5398500" cy="318600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82217" y="2136360"/>
            <a:ext cx="5398500" cy="31860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66255" y="124691"/>
            <a:ext cx="2657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S2A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320162" y="4488006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=0.093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684878" y="4988104"/>
            <a:ext cx="14282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Time (months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0800000">
            <a:off x="510512" y="2689004"/>
            <a:ext cx="430887" cy="173098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Overall survival (%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32" name="표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3560984"/>
              </p:ext>
            </p:extLst>
          </p:nvPr>
        </p:nvGraphicFramePr>
        <p:xfrm>
          <a:off x="18843" y="5375228"/>
          <a:ext cx="6286318" cy="520152"/>
        </p:xfrm>
        <a:graphic>
          <a:graphicData uri="http://schemas.openxmlformats.org/drawingml/2006/table">
            <a:tbl>
              <a:tblPr/>
              <a:tblGrid>
                <a:gridCol w="1044000">
                  <a:extLst>
                    <a:ext uri="{9D8B030D-6E8A-4147-A177-3AD203B41FA5}">
                      <a16:colId xmlns:a16="http://schemas.microsoft.com/office/drawing/2014/main" val="3641363282"/>
                    </a:ext>
                  </a:extLst>
                </a:gridCol>
                <a:gridCol w="791544">
                  <a:extLst>
                    <a:ext uri="{9D8B030D-6E8A-4147-A177-3AD203B41FA5}">
                      <a16:colId xmlns:a16="http://schemas.microsoft.com/office/drawing/2014/main" val="1399146309"/>
                    </a:ext>
                  </a:extLst>
                </a:gridCol>
                <a:gridCol w="798022">
                  <a:extLst>
                    <a:ext uri="{9D8B030D-6E8A-4147-A177-3AD203B41FA5}">
                      <a16:colId xmlns:a16="http://schemas.microsoft.com/office/drawing/2014/main" val="1474105335"/>
                    </a:ext>
                  </a:extLst>
                </a:gridCol>
                <a:gridCol w="756458">
                  <a:extLst>
                    <a:ext uri="{9D8B030D-6E8A-4147-A177-3AD203B41FA5}">
                      <a16:colId xmlns:a16="http://schemas.microsoft.com/office/drawing/2014/main" val="280477039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75556681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69616439"/>
                    </a:ext>
                  </a:extLst>
                </a:gridCol>
                <a:gridCol w="806335">
                  <a:extLst>
                    <a:ext uri="{9D8B030D-6E8A-4147-A177-3AD203B41FA5}">
                      <a16:colId xmlns:a16="http://schemas.microsoft.com/office/drawing/2014/main" val="3056659563"/>
                    </a:ext>
                  </a:extLst>
                </a:gridCol>
                <a:gridCol w="626919">
                  <a:extLst>
                    <a:ext uri="{9D8B030D-6E8A-4147-A177-3AD203B41FA5}">
                      <a16:colId xmlns:a16="http://schemas.microsoft.com/office/drawing/2014/main" val="3411186500"/>
                    </a:ext>
                  </a:extLst>
                </a:gridCol>
              </a:tblGrid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LD combined 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705597"/>
                  </a:ext>
                </a:extLst>
              </a:tr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0191494"/>
                  </a:ext>
                </a:extLst>
              </a:tr>
            </a:tbl>
          </a:graphicData>
        </a:graphic>
      </p:graphicFrame>
      <p:cxnSp>
        <p:nvCxnSpPr>
          <p:cNvPr id="33" name="직선 연결선 32"/>
          <p:cNvCxnSpPr/>
          <p:nvPr/>
        </p:nvCxnSpPr>
        <p:spPr>
          <a:xfrm>
            <a:off x="3397366" y="2360528"/>
            <a:ext cx="46800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/>
          <p:cNvCxnSpPr/>
          <p:nvPr/>
        </p:nvCxnSpPr>
        <p:spPr>
          <a:xfrm flipV="1">
            <a:off x="3397366" y="2056747"/>
            <a:ext cx="468000" cy="52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5" name="표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1348417"/>
              </p:ext>
            </p:extLst>
          </p:nvPr>
        </p:nvGraphicFramePr>
        <p:xfrm>
          <a:off x="3964825" y="1888859"/>
          <a:ext cx="239250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4000">
                  <a:extLst>
                    <a:ext uri="{9D8B030D-6E8A-4147-A177-3AD203B41FA5}">
                      <a16:colId xmlns:a16="http://schemas.microsoft.com/office/drawing/2014/main" val="4054309642"/>
                    </a:ext>
                  </a:extLst>
                </a:gridCol>
                <a:gridCol w="1168500">
                  <a:extLst>
                    <a:ext uri="{9D8B030D-6E8A-4147-A177-3AD203B41FA5}">
                      <a16:colId xmlns:a16="http://schemas.microsoft.com/office/drawing/2014/main" val="1883565153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D combined RT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6.0 (2.7-29.2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45897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orafenib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1 (2.2-4.0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1441797"/>
                  </a:ext>
                </a:extLst>
              </a:tr>
            </a:tbl>
          </a:graphicData>
        </a:graphic>
      </p:graphicFrame>
      <p:sp>
        <p:nvSpPr>
          <p:cNvPr id="36" name="TextBox 35"/>
          <p:cNvSpPr txBox="1"/>
          <p:nvPr/>
        </p:nvSpPr>
        <p:spPr>
          <a:xfrm>
            <a:off x="3964825" y="1622283"/>
            <a:ext cx="2010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Median OS, months (95% CI)</a:t>
            </a:r>
            <a:endParaRPr lang="ko-KR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964825" y="2458344"/>
            <a:ext cx="24400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HR 0.47 (95% CI 0.19-1.16; </a:t>
            </a:r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=0.093)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860848" y="4988901"/>
            <a:ext cx="14282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Time (months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6" name="직선 연결선 55"/>
          <p:cNvCxnSpPr/>
          <p:nvPr/>
        </p:nvCxnSpPr>
        <p:spPr>
          <a:xfrm>
            <a:off x="9265977" y="2323098"/>
            <a:ext cx="46800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/>
          <p:cNvCxnSpPr/>
          <p:nvPr/>
        </p:nvCxnSpPr>
        <p:spPr>
          <a:xfrm flipV="1">
            <a:off x="9265977" y="2019317"/>
            <a:ext cx="468000" cy="52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8" name="표 5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3854918"/>
              </p:ext>
            </p:extLst>
          </p:nvPr>
        </p:nvGraphicFramePr>
        <p:xfrm>
          <a:off x="9833436" y="1851429"/>
          <a:ext cx="239250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4000">
                  <a:extLst>
                    <a:ext uri="{9D8B030D-6E8A-4147-A177-3AD203B41FA5}">
                      <a16:colId xmlns:a16="http://schemas.microsoft.com/office/drawing/2014/main" val="4054309642"/>
                    </a:ext>
                  </a:extLst>
                </a:gridCol>
                <a:gridCol w="1168500">
                  <a:extLst>
                    <a:ext uri="{9D8B030D-6E8A-4147-A177-3AD203B41FA5}">
                      <a16:colId xmlns:a16="http://schemas.microsoft.com/office/drawing/2014/main" val="1883565153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D combined RT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2.0 (9.5-14.5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45897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orafenib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5 (3.7-5.3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1441797"/>
                  </a:ext>
                </a:extLst>
              </a:tr>
            </a:tbl>
          </a:graphicData>
        </a:graphic>
      </p:graphicFrame>
      <p:sp>
        <p:nvSpPr>
          <p:cNvPr id="59" name="TextBox 58"/>
          <p:cNvSpPr txBox="1"/>
          <p:nvPr/>
        </p:nvSpPr>
        <p:spPr>
          <a:xfrm>
            <a:off x="9833436" y="1584853"/>
            <a:ext cx="2010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Median OS, months (95% CI)</a:t>
            </a:r>
            <a:endParaRPr lang="ko-KR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9833436" y="2420914"/>
            <a:ext cx="2441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HR 0.49 (95% CI 0.39-0.62; </a:t>
            </a:r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&lt;0.001)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61" name="표 6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1073072"/>
              </p:ext>
            </p:extLst>
          </p:nvPr>
        </p:nvGraphicFramePr>
        <p:xfrm>
          <a:off x="6118255" y="5375228"/>
          <a:ext cx="6127399" cy="520152"/>
        </p:xfrm>
        <a:graphic>
          <a:graphicData uri="http://schemas.openxmlformats.org/drawingml/2006/table">
            <a:tbl>
              <a:tblPr/>
              <a:tblGrid>
                <a:gridCol w="1008000">
                  <a:extLst>
                    <a:ext uri="{9D8B030D-6E8A-4147-A177-3AD203B41FA5}">
                      <a16:colId xmlns:a16="http://schemas.microsoft.com/office/drawing/2014/main" val="3641363282"/>
                    </a:ext>
                  </a:extLst>
                </a:gridCol>
                <a:gridCol w="791544">
                  <a:extLst>
                    <a:ext uri="{9D8B030D-6E8A-4147-A177-3AD203B41FA5}">
                      <a16:colId xmlns:a16="http://schemas.microsoft.com/office/drawing/2014/main" val="1399146309"/>
                    </a:ext>
                  </a:extLst>
                </a:gridCol>
                <a:gridCol w="798022">
                  <a:extLst>
                    <a:ext uri="{9D8B030D-6E8A-4147-A177-3AD203B41FA5}">
                      <a16:colId xmlns:a16="http://schemas.microsoft.com/office/drawing/2014/main" val="1474105335"/>
                    </a:ext>
                  </a:extLst>
                </a:gridCol>
                <a:gridCol w="756458">
                  <a:extLst>
                    <a:ext uri="{9D8B030D-6E8A-4147-A177-3AD203B41FA5}">
                      <a16:colId xmlns:a16="http://schemas.microsoft.com/office/drawing/2014/main" val="280477039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75556681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69616439"/>
                    </a:ext>
                  </a:extLst>
                </a:gridCol>
                <a:gridCol w="806335">
                  <a:extLst>
                    <a:ext uri="{9D8B030D-6E8A-4147-A177-3AD203B41FA5}">
                      <a16:colId xmlns:a16="http://schemas.microsoft.com/office/drawing/2014/main" val="3056659563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3411186500"/>
                    </a:ext>
                  </a:extLst>
                </a:gridCol>
              </a:tblGrid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LD combined 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6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8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705597"/>
                  </a:ext>
                </a:extLst>
              </a:tr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0191494"/>
                  </a:ext>
                </a:extLst>
              </a:tr>
            </a:tbl>
          </a:graphicData>
        </a:graphic>
      </p:graphicFrame>
      <p:sp>
        <p:nvSpPr>
          <p:cNvPr id="40" name="TextBox 39"/>
          <p:cNvSpPr txBox="1"/>
          <p:nvPr/>
        </p:nvSpPr>
        <p:spPr>
          <a:xfrm>
            <a:off x="2655207" y="1254917"/>
            <a:ext cx="11479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PVTT type I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585937" y="1254917"/>
            <a:ext cx="12024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PVTT type II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0800000">
            <a:off x="6682218" y="2706777"/>
            <a:ext cx="430887" cy="173098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Overall survival (%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1" name="직선 연결선 50"/>
          <p:cNvCxnSpPr/>
          <p:nvPr/>
        </p:nvCxnSpPr>
        <p:spPr>
          <a:xfrm flipH="1">
            <a:off x="1329053" y="3571078"/>
            <a:ext cx="2710" cy="1260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 flipH="1">
            <a:off x="2285659" y="3571078"/>
            <a:ext cx="2710" cy="1260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/>
          <p:cNvCxnSpPr/>
          <p:nvPr/>
        </p:nvCxnSpPr>
        <p:spPr>
          <a:xfrm flipV="1">
            <a:off x="1080077" y="3555644"/>
            <a:ext cx="1224000" cy="1570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61"/>
          <p:cNvCxnSpPr/>
          <p:nvPr/>
        </p:nvCxnSpPr>
        <p:spPr>
          <a:xfrm flipH="1">
            <a:off x="7567921" y="3580315"/>
            <a:ext cx="2710" cy="1260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62"/>
          <p:cNvCxnSpPr/>
          <p:nvPr/>
        </p:nvCxnSpPr>
        <p:spPr>
          <a:xfrm flipH="1">
            <a:off x="8110515" y="3584208"/>
            <a:ext cx="2710" cy="1260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/>
          <p:cNvCxnSpPr/>
          <p:nvPr/>
        </p:nvCxnSpPr>
        <p:spPr>
          <a:xfrm flipV="1">
            <a:off x="7244313" y="3571078"/>
            <a:ext cx="864000" cy="1313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8108313" y="4488006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&lt;0.001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306763" y="124691"/>
            <a:ext cx="264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S2B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51782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6811" y="2130835"/>
            <a:ext cx="5398500" cy="318600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41544" y="2134172"/>
            <a:ext cx="5398500" cy="31860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66255" y="124691"/>
            <a:ext cx="264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S2C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66244" y="4507545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&lt;0.001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668252" y="4988104"/>
            <a:ext cx="14282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Time (months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0800000">
            <a:off x="493886" y="2689004"/>
            <a:ext cx="430887" cy="173098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Overall survival (%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32" name="표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34058"/>
              </p:ext>
            </p:extLst>
          </p:nvPr>
        </p:nvGraphicFramePr>
        <p:xfrm>
          <a:off x="30863" y="5377022"/>
          <a:ext cx="6250318" cy="520152"/>
        </p:xfrm>
        <a:graphic>
          <a:graphicData uri="http://schemas.openxmlformats.org/drawingml/2006/table">
            <a:tbl>
              <a:tblPr/>
              <a:tblGrid>
                <a:gridCol w="1008000">
                  <a:extLst>
                    <a:ext uri="{9D8B030D-6E8A-4147-A177-3AD203B41FA5}">
                      <a16:colId xmlns:a16="http://schemas.microsoft.com/office/drawing/2014/main" val="3641363282"/>
                    </a:ext>
                  </a:extLst>
                </a:gridCol>
                <a:gridCol w="791544">
                  <a:extLst>
                    <a:ext uri="{9D8B030D-6E8A-4147-A177-3AD203B41FA5}">
                      <a16:colId xmlns:a16="http://schemas.microsoft.com/office/drawing/2014/main" val="1399146309"/>
                    </a:ext>
                  </a:extLst>
                </a:gridCol>
                <a:gridCol w="798022">
                  <a:extLst>
                    <a:ext uri="{9D8B030D-6E8A-4147-A177-3AD203B41FA5}">
                      <a16:colId xmlns:a16="http://schemas.microsoft.com/office/drawing/2014/main" val="1474105335"/>
                    </a:ext>
                  </a:extLst>
                </a:gridCol>
                <a:gridCol w="756458">
                  <a:extLst>
                    <a:ext uri="{9D8B030D-6E8A-4147-A177-3AD203B41FA5}">
                      <a16:colId xmlns:a16="http://schemas.microsoft.com/office/drawing/2014/main" val="280477039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75556681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69616439"/>
                    </a:ext>
                  </a:extLst>
                </a:gridCol>
                <a:gridCol w="806335">
                  <a:extLst>
                    <a:ext uri="{9D8B030D-6E8A-4147-A177-3AD203B41FA5}">
                      <a16:colId xmlns:a16="http://schemas.microsoft.com/office/drawing/2014/main" val="3056659563"/>
                    </a:ext>
                  </a:extLst>
                </a:gridCol>
                <a:gridCol w="626919">
                  <a:extLst>
                    <a:ext uri="{9D8B030D-6E8A-4147-A177-3AD203B41FA5}">
                      <a16:colId xmlns:a16="http://schemas.microsoft.com/office/drawing/2014/main" val="3411186500"/>
                    </a:ext>
                  </a:extLst>
                </a:gridCol>
              </a:tblGrid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LD combined 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705597"/>
                  </a:ext>
                </a:extLst>
              </a:tr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0191494"/>
                  </a:ext>
                </a:extLst>
              </a:tr>
            </a:tbl>
          </a:graphicData>
        </a:graphic>
      </p:graphicFrame>
      <p:cxnSp>
        <p:nvCxnSpPr>
          <p:cNvPr id="33" name="직선 연결선 32"/>
          <p:cNvCxnSpPr/>
          <p:nvPr/>
        </p:nvCxnSpPr>
        <p:spPr>
          <a:xfrm>
            <a:off x="3380740" y="2360528"/>
            <a:ext cx="46800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/>
          <p:cNvCxnSpPr/>
          <p:nvPr/>
        </p:nvCxnSpPr>
        <p:spPr>
          <a:xfrm flipV="1">
            <a:off x="3380740" y="2056747"/>
            <a:ext cx="468000" cy="52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5" name="표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6530715"/>
              </p:ext>
            </p:extLst>
          </p:nvPr>
        </p:nvGraphicFramePr>
        <p:xfrm>
          <a:off x="3948199" y="1888859"/>
          <a:ext cx="239250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4000">
                  <a:extLst>
                    <a:ext uri="{9D8B030D-6E8A-4147-A177-3AD203B41FA5}">
                      <a16:colId xmlns:a16="http://schemas.microsoft.com/office/drawing/2014/main" val="4054309642"/>
                    </a:ext>
                  </a:extLst>
                </a:gridCol>
                <a:gridCol w="1168500">
                  <a:extLst>
                    <a:ext uri="{9D8B030D-6E8A-4147-A177-3AD203B41FA5}">
                      <a16:colId xmlns:a16="http://schemas.microsoft.com/office/drawing/2014/main" val="1883565153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D combined RT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.3 (7.6-11.1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45897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orafenib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5 (2.3-4.7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1441797"/>
                  </a:ext>
                </a:extLst>
              </a:tr>
            </a:tbl>
          </a:graphicData>
        </a:graphic>
      </p:graphicFrame>
      <p:sp>
        <p:nvSpPr>
          <p:cNvPr id="36" name="TextBox 35"/>
          <p:cNvSpPr txBox="1"/>
          <p:nvPr/>
        </p:nvSpPr>
        <p:spPr>
          <a:xfrm>
            <a:off x="3948199" y="1622283"/>
            <a:ext cx="2010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Median OS, months (95% CI)</a:t>
            </a:r>
            <a:endParaRPr lang="ko-KR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948199" y="2458344"/>
            <a:ext cx="2441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HR 0.56 (95% CI 0.43-0.73; </a:t>
            </a:r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&lt;0.001)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802657" y="4988901"/>
            <a:ext cx="14282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Time (months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186122" y="4507545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=0.754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6" name="직선 연결선 55"/>
          <p:cNvCxnSpPr/>
          <p:nvPr/>
        </p:nvCxnSpPr>
        <p:spPr>
          <a:xfrm>
            <a:off x="9257664" y="2198408"/>
            <a:ext cx="46800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/>
          <p:cNvCxnSpPr/>
          <p:nvPr/>
        </p:nvCxnSpPr>
        <p:spPr>
          <a:xfrm flipV="1">
            <a:off x="9257664" y="1894627"/>
            <a:ext cx="468000" cy="52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8" name="표 5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2501225"/>
              </p:ext>
            </p:extLst>
          </p:nvPr>
        </p:nvGraphicFramePr>
        <p:xfrm>
          <a:off x="9825123" y="1726739"/>
          <a:ext cx="239250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4000">
                  <a:extLst>
                    <a:ext uri="{9D8B030D-6E8A-4147-A177-3AD203B41FA5}">
                      <a16:colId xmlns:a16="http://schemas.microsoft.com/office/drawing/2014/main" val="4054309642"/>
                    </a:ext>
                  </a:extLst>
                </a:gridCol>
                <a:gridCol w="1168500">
                  <a:extLst>
                    <a:ext uri="{9D8B030D-6E8A-4147-A177-3AD203B41FA5}">
                      <a16:colId xmlns:a16="http://schemas.microsoft.com/office/drawing/2014/main" val="1883565153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D combined RT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6 (NE-NE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45897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orafenib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aseline="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2 (0.8-3.6</a:t>
                      </a:r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1441797"/>
                  </a:ext>
                </a:extLst>
              </a:tr>
            </a:tbl>
          </a:graphicData>
        </a:graphic>
      </p:graphicFrame>
      <p:sp>
        <p:nvSpPr>
          <p:cNvPr id="59" name="TextBox 58"/>
          <p:cNvSpPr txBox="1"/>
          <p:nvPr/>
        </p:nvSpPr>
        <p:spPr>
          <a:xfrm>
            <a:off x="9825123" y="1460163"/>
            <a:ext cx="2010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Median OS, months (95% CI)</a:t>
            </a:r>
            <a:endParaRPr lang="ko-KR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9825123" y="2296224"/>
            <a:ext cx="2441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HR 0.69 (95% CI 0.07-7.07; </a:t>
            </a:r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=0.754)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61" name="표 6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3102685"/>
              </p:ext>
            </p:extLst>
          </p:nvPr>
        </p:nvGraphicFramePr>
        <p:xfrm>
          <a:off x="6240259" y="5375228"/>
          <a:ext cx="5995637" cy="520152"/>
        </p:xfrm>
        <a:graphic>
          <a:graphicData uri="http://schemas.openxmlformats.org/drawingml/2006/table">
            <a:tbl>
              <a:tblPr/>
              <a:tblGrid>
                <a:gridCol w="1008000">
                  <a:extLst>
                    <a:ext uri="{9D8B030D-6E8A-4147-A177-3AD203B41FA5}">
                      <a16:colId xmlns:a16="http://schemas.microsoft.com/office/drawing/2014/main" val="3641363282"/>
                    </a:ext>
                  </a:extLst>
                </a:gridCol>
                <a:gridCol w="872837">
                  <a:extLst>
                    <a:ext uri="{9D8B030D-6E8A-4147-A177-3AD203B41FA5}">
                      <a16:colId xmlns:a16="http://schemas.microsoft.com/office/drawing/2014/main" val="1399146309"/>
                    </a:ext>
                  </a:extLst>
                </a:gridCol>
                <a:gridCol w="939338">
                  <a:extLst>
                    <a:ext uri="{9D8B030D-6E8A-4147-A177-3AD203B41FA5}">
                      <a16:colId xmlns:a16="http://schemas.microsoft.com/office/drawing/2014/main" val="1474105335"/>
                    </a:ext>
                  </a:extLst>
                </a:gridCol>
                <a:gridCol w="939338">
                  <a:extLst>
                    <a:ext uri="{9D8B030D-6E8A-4147-A177-3AD203B41FA5}">
                      <a16:colId xmlns:a16="http://schemas.microsoft.com/office/drawing/2014/main" val="2804770392"/>
                    </a:ext>
                  </a:extLst>
                </a:gridCol>
                <a:gridCol w="922713">
                  <a:extLst>
                    <a:ext uri="{9D8B030D-6E8A-4147-A177-3AD203B41FA5}">
                      <a16:colId xmlns:a16="http://schemas.microsoft.com/office/drawing/2014/main" val="755566812"/>
                    </a:ext>
                  </a:extLst>
                </a:gridCol>
                <a:gridCol w="872836">
                  <a:extLst>
                    <a:ext uri="{9D8B030D-6E8A-4147-A177-3AD203B41FA5}">
                      <a16:colId xmlns:a16="http://schemas.microsoft.com/office/drawing/2014/main" val="3786663617"/>
                    </a:ext>
                  </a:extLst>
                </a:gridCol>
                <a:gridCol w="440575">
                  <a:extLst>
                    <a:ext uri="{9D8B030D-6E8A-4147-A177-3AD203B41FA5}">
                      <a16:colId xmlns:a16="http://schemas.microsoft.com/office/drawing/2014/main" val="1069616439"/>
                    </a:ext>
                  </a:extLst>
                </a:gridCol>
              </a:tblGrid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LD combined 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705597"/>
                  </a:ext>
                </a:extLst>
              </a:tr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0191494"/>
                  </a:ext>
                </a:extLst>
              </a:tr>
            </a:tbl>
          </a:graphicData>
        </a:graphic>
      </p:graphicFrame>
      <p:sp>
        <p:nvSpPr>
          <p:cNvPr id="40" name="TextBox 39"/>
          <p:cNvSpPr txBox="1"/>
          <p:nvPr/>
        </p:nvSpPr>
        <p:spPr>
          <a:xfrm>
            <a:off x="2638581" y="1254917"/>
            <a:ext cx="12569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PVTT type III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477868" y="1254917"/>
            <a:ext cx="12697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PVTT type IV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0800000">
            <a:off x="6624027" y="2706777"/>
            <a:ext cx="430887" cy="173098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Overall survival (%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1" name="직선 연결선 50"/>
          <p:cNvCxnSpPr/>
          <p:nvPr/>
        </p:nvCxnSpPr>
        <p:spPr>
          <a:xfrm flipH="1">
            <a:off x="1320586" y="3565292"/>
            <a:ext cx="2710" cy="1260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 flipH="1">
            <a:off x="1763380" y="3579658"/>
            <a:ext cx="2710" cy="1260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/>
          <p:cNvCxnSpPr/>
          <p:nvPr/>
        </p:nvCxnSpPr>
        <p:spPr>
          <a:xfrm>
            <a:off x="1063451" y="3580678"/>
            <a:ext cx="720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61"/>
          <p:cNvCxnSpPr/>
          <p:nvPr/>
        </p:nvCxnSpPr>
        <p:spPr>
          <a:xfrm flipH="1">
            <a:off x="8178359" y="3581701"/>
            <a:ext cx="2710" cy="1260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/>
          <p:cNvCxnSpPr/>
          <p:nvPr/>
        </p:nvCxnSpPr>
        <p:spPr>
          <a:xfrm flipV="1">
            <a:off x="7186122" y="3563032"/>
            <a:ext cx="2520000" cy="20713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6306763" y="124691"/>
            <a:ext cx="26673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S2D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24547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1404" y="2125334"/>
            <a:ext cx="5398500" cy="3186000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28916" y="2125334"/>
            <a:ext cx="5398500" cy="31860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66255" y="124691"/>
            <a:ext cx="2657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S3A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167354" y="4462938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&lt;0.001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709817" y="4988104"/>
            <a:ext cx="14282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Time (months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0800000">
            <a:off x="535451" y="2689004"/>
            <a:ext cx="430887" cy="173098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Overall survival (%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32" name="표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4184882"/>
              </p:ext>
            </p:extLst>
          </p:nvPr>
        </p:nvGraphicFramePr>
        <p:xfrm>
          <a:off x="30863" y="5377022"/>
          <a:ext cx="6250318" cy="520152"/>
        </p:xfrm>
        <a:graphic>
          <a:graphicData uri="http://schemas.openxmlformats.org/drawingml/2006/table">
            <a:tbl>
              <a:tblPr/>
              <a:tblGrid>
                <a:gridCol w="1008000">
                  <a:extLst>
                    <a:ext uri="{9D8B030D-6E8A-4147-A177-3AD203B41FA5}">
                      <a16:colId xmlns:a16="http://schemas.microsoft.com/office/drawing/2014/main" val="3641363282"/>
                    </a:ext>
                  </a:extLst>
                </a:gridCol>
                <a:gridCol w="791544">
                  <a:extLst>
                    <a:ext uri="{9D8B030D-6E8A-4147-A177-3AD203B41FA5}">
                      <a16:colId xmlns:a16="http://schemas.microsoft.com/office/drawing/2014/main" val="1399146309"/>
                    </a:ext>
                  </a:extLst>
                </a:gridCol>
                <a:gridCol w="798022">
                  <a:extLst>
                    <a:ext uri="{9D8B030D-6E8A-4147-A177-3AD203B41FA5}">
                      <a16:colId xmlns:a16="http://schemas.microsoft.com/office/drawing/2014/main" val="1474105335"/>
                    </a:ext>
                  </a:extLst>
                </a:gridCol>
                <a:gridCol w="756458">
                  <a:extLst>
                    <a:ext uri="{9D8B030D-6E8A-4147-A177-3AD203B41FA5}">
                      <a16:colId xmlns:a16="http://schemas.microsoft.com/office/drawing/2014/main" val="280477039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75556681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69616439"/>
                    </a:ext>
                  </a:extLst>
                </a:gridCol>
                <a:gridCol w="806335">
                  <a:extLst>
                    <a:ext uri="{9D8B030D-6E8A-4147-A177-3AD203B41FA5}">
                      <a16:colId xmlns:a16="http://schemas.microsoft.com/office/drawing/2014/main" val="3056659563"/>
                    </a:ext>
                  </a:extLst>
                </a:gridCol>
                <a:gridCol w="626919">
                  <a:extLst>
                    <a:ext uri="{9D8B030D-6E8A-4147-A177-3AD203B41FA5}">
                      <a16:colId xmlns:a16="http://schemas.microsoft.com/office/drawing/2014/main" val="3411186500"/>
                    </a:ext>
                  </a:extLst>
                </a:gridCol>
              </a:tblGrid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LD combined 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4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9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705597"/>
                  </a:ext>
                </a:extLst>
              </a:tr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0191494"/>
                  </a:ext>
                </a:extLst>
              </a:tr>
            </a:tbl>
          </a:graphicData>
        </a:graphic>
      </p:graphicFrame>
      <p:cxnSp>
        <p:nvCxnSpPr>
          <p:cNvPr id="33" name="직선 연결선 32"/>
          <p:cNvCxnSpPr/>
          <p:nvPr/>
        </p:nvCxnSpPr>
        <p:spPr>
          <a:xfrm>
            <a:off x="3422305" y="2360528"/>
            <a:ext cx="46800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/>
          <p:cNvCxnSpPr/>
          <p:nvPr/>
        </p:nvCxnSpPr>
        <p:spPr>
          <a:xfrm flipV="1">
            <a:off x="3422305" y="2056747"/>
            <a:ext cx="468000" cy="52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5" name="표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33205366"/>
              </p:ext>
            </p:extLst>
          </p:nvPr>
        </p:nvGraphicFramePr>
        <p:xfrm>
          <a:off x="3989764" y="1888859"/>
          <a:ext cx="239250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4000">
                  <a:extLst>
                    <a:ext uri="{9D8B030D-6E8A-4147-A177-3AD203B41FA5}">
                      <a16:colId xmlns:a16="http://schemas.microsoft.com/office/drawing/2014/main" val="4054309642"/>
                    </a:ext>
                  </a:extLst>
                </a:gridCol>
                <a:gridCol w="1168500">
                  <a:extLst>
                    <a:ext uri="{9D8B030D-6E8A-4147-A177-3AD203B41FA5}">
                      <a16:colId xmlns:a16="http://schemas.microsoft.com/office/drawing/2014/main" val="1883565153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D combined RT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5 (10.0-16.9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45897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orafenib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1 (3.6-8.6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1441797"/>
                  </a:ext>
                </a:extLst>
              </a:tr>
            </a:tbl>
          </a:graphicData>
        </a:graphic>
      </p:graphicFrame>
      <p:sp>
        <p:nvSpPr>
          <p:cNvPr id="36" name="TextBox 35"/>
          <p:cNvSpPr txBox="1"/>
          <p:nvPr/>
        </p:nvSpPr>
        <p:spPr>
          <a:xfrm>
            <a:off x="3989764" y="1622283"/>
            <a:ext cx="2010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Median OS, months (95% CI)</a:t>
            </a:r>
            <a:endParaRPr lang="ko-KR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989764" y="2458344"/>
            <a:ext cx="2441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HR 0.55 (95% CI 0.42-0.71; </a:t>
            </a:r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&lt;0.001)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794344" y="4988901"/>
            <a:ext cx="14282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Time (months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723931" y="4497840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&lt;0.001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6" name="직선 연결선 55"/>
          <p:cNvCxnSpPr/>
          <p:nvPr/>
        </p:nvCxnSpPr>
        <p:spPr>
          <a:xfrm>
            <a:off x="9232725" y="2323098"/>
            <a:ext cx="46800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/>
          <p:cNvCxnSpPr/>
          <p:nvPr/>
        </p:nvCxnSpPr>
        <p:spPr>
          <a:xfrm flipV="1">
            <a:off x="9232725" y="2019317"/>
            <a:ext cx="468000" cy="526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8" name="표 5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602272"/>
              </p:ext>
            </p:extLst>
          </p:nvPr>
        </p:nvGraphicFramePr>
        <p:xfrm>
          <a:off x="9800184" y="1851429"/>
          <a:ext cx="2392500" cy="5486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24000">
                  <a:extLst>
                    <a:ext uri="{9D8B030D-6E8A-4147-A177-3AD203B41FA5}">
                      <a16:colId xmlns:a16="http://schemas.microsoft.com/office/drawing/2014/main" val="4054309642"/>
                    </a:ext>
                  </a:extLst>
                </a:gridCol>
                <a:gridCol w="1168500">
                  <a:extLst>
                    <a:ext uri="{9D8B030D-6E8A-4147-A177-3AD203B41FA5}">
                      <a16:colId xmlns:a16="http://schemas.microsoft.com/office/drawing/2014/main" val="1883565153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D combined RT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.1 (6.9-9.3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45897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orafenib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2 (2.6-3.9)</a:t>
                      </a:r>
                      <a:endParaRPr lang="ko-KR" altLang="en-US" sz="12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1441797"/>
                  </a:ext>
                </a:extLst>
              </a:tr>
            </a:tbl>
          </a:graphicData>
        </a:graphic>
      </p:graphicFrame>
      <p:sp>
        <p:nvSpPr>
          <p:cNvPr id="59" name="TextBox 58"/>
          <p:cNvSpPr txBox="1"/>
          <p:nvPr/>
        </p:nvSpPr>
        <p:spPr>
          <a:xfrm>
            <a:off x="9800184" y="1584853"/>
            <a:ext cx="2010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Median OS, months (95% CI)</a:t>
            </a:r>
            <a:endParaRPr lang="ko-KR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9800184" y="2420914"/>
            <a:ext cx="2441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HR 0.51 (95% CI 0.41-0.64; </a:t>
            </a:r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&lt;0.001)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61" name="표 6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950605"/>
              </p:ext>
            </p:extLst>
          </p:nvPr>
        </p:nvGraphicFramePr>
        <p:xfrm>
          <a:off x="6165442" y="5375228"/>
          <a:ext cx="6127399" cy="520152"/>
        </p:xfrm>
        <a:graphic>
          <a:graphicData uri="http://schemas.openxmlformats.org/drawingml/2006/table">
            <a:tbl>
              <a:tblPr/>
              <a:tblGrid>
                <a:gridCol w="1008000">
                  <a:extLst>
                    <a:ext uri="{9D8B030D-6E8A-4147-A177-3AD203B41FA5}">
                      <a16:colId xmlns:a16="http://schemas.microsoft.com/office/drawing/2014/main" val="3641363282"/>
                    </a:ext>
                  </a:extLst>
                </a:gridCol>
                <a:gridCol w="791544">
                  <a:extLst>
                    <a:ext uri="{9D8B030D-6E8A-4147-A177-3AD203B41FA5}">
                      <a16:colId xmlns:a16="http://schemas.microsoft.com/office/drawing/2014/main" val="1399146309"/>
                    </a:ext>
                  </a:extLst>
                </a:gridCol>
                <a:gridCol w="798022">
                  <a:extLst>
                    <a:ext uri="{9D8B030D-6E8A-4147-A177-3AD203B41FA5}">
                      <a16:colId xmlns:a16="http://schemas.microsoft.com/office/drawing/2014/main" val="1474105335"/>
                    </a:ext>
                  </a:extLst>
                </a:gridCol>
                <a:gridCol w="756458">
                  <a:extLst>
                    <a:ext uri="{9D8B030D-6E8A-4147-A177-3AD203B41FA5}">
                      <a16:colId xmlns:a16="http://schemas.microsoft.com/office/drawing/2014/main" val="280477039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75556681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69616439"/>
                    </a:ext>
                  </a:extLst>
                </a:gridCol>
                <a:gridCol w="806335">
                  <a:extLst>
                    <a:ext uri="{9D8B030D-6E8A-4147-A177-3AD203B41FA5}">
                      <a16:colId xmlns:a16="http://schemas.microsoft.com/office/drawing/2014/main" val="3056659563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3411186500"/>
                    </a:ext>
                  </a:extLst>
                </a:gridCol>
              </a:tblGrid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LD combined 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705597"/>
                  </a:ext>
                </a:extLst>
              </a:tr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8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0191494"/>
                  </a:ext>
                </a:extLst>
              </a:tr>
            </a:tbl>
          </a:graphicData>
        </a:graphic>
      </p:graphicFrame>
      <p:sp>
        <p:nvSpPr>
          <p:cNvPr id="40" name="TextBox 39"/>
          <p:cNvSpPr txBox="1"/>
          <p:nvPr/>
        </p:nvSpPr>
        <p:spPr>
          <a:xfrm>
            <a:off x="2680146" y="1254917"/>
            <a:ext cx="15772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AFP ≤400 ng/mL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552685" y="1254917"/>
            <a:ext cx="15772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AFP &gt;400 ng/mL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0800000">
            <a:off x="6615714" y="2706777"/>
            <a:ext cx="430887" cy="173098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Overall survival (%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1" name="직선 연결선 50"/>
          <p:cNvCxnSpPr/>
          <p:nvPr/>
        </p:nvCxnSpPr>
        <p:spPr>
          <a:xfrm flipH="1">
            <a:off x="1546014" y="3572270"/>
            <a:ext cx="2710" cy="1260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 flipH="1">
            <a:off x="2176232" y="3579658"/>
            <a:ext cx="2710" cy="1260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/>
          <p:cNvCxnSpPr/>
          <p:nvPr/>
        </p:nvCxnSpPr>
        <p:spPr>
          <a:xfrm>
            <a:off x="1105016" y="3580678"/>
            <a:ext cx="1080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61"/>
          <p:cNvCxnSpPr/>
          <p:nvPr/>
        </p:nvCxnSpPr>
        <p:spPr>
          <a:xfrm flipH="1">
            <a:off x="7411191" y="3579658"/>
            <a:ext cx="2710" cy="1260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62"/>
          <p:cNvCxnSpPr/>
          <p:nvPr/>
        </p:nvCxnSpPr>
        <p:spPr>
          <a:xfrm flipH="1">
            <a:off x="7775711" y="3581701"/>
            <a:ext cx="2710" cy="1260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6306763" y="124691"/>
            <a:ext cx="264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S3B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9" name="직선 연결선 38"/>
          <p:cNvCxnSpPr/>
          <p:nvPr/>
        </p:nvCxnSpPr>
        <p:spPr>
          <a:xfrm>
            <a:off x="7167305" y="3616699"/>
            <a:ext cx="648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943937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66255" y="124691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S4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53520" y="1086891"/>
            <a:ext cx="8134350" cy="4800600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4181304" y="4778228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&lt;0.001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827223" y="5453137"/>
            <a:ext cx="1581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Calibri" panose="020F0502020204030204" pitchFamily="34" charset="0"/>
                <a:cs typeface="Calibri" panose="020F0502020204030204" pitchFamily="34" charset="0"/>
              </a:rPr>
              <a:t>Time (months)</a:t>
            </a:r>
            <a:endParaRPr lang="ko-KR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0800000">
            <a:off x="2161312" y="2286076"/>
            <a:ext cx="461665" cy="193046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b="1" dirty="0">
                <a:latin typeface="Calibri" panose="020F0502020204030204" pitchFamily="34" charset="0"/>
                <a:cs typeface="Calibri" panose="020F0502020204030204" pitchFamily="34" charset="0"/>
              </a:rPr>
              <a:t>Overall survival (%)</a:t>
            </a:r>
            <a:endParaRPr lang="ko-KR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6" name="직선 연결선 45"/>
          <p:cNvCxnSpPr/>
          <p:nvPr/>
        </p:nvCxnSpPr>
        <p:spPr>
          <a:xfrm>
            <a:off x="2942705" y="3283515"/>
            <a:ext cx="1116000" cy="8313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7" name="표 4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7208149"/>
              </p:ext>
            </p:extLst>
          </p:nvPr>
        </p:nvGraphicFramePr>
        <p:xfrm>
          <a:off x="1592440" y="5847398"/>
          <a:ext cx="8832173" cy="520152"/>
        </p:xfrm>
        <a:graphic>
          <a:graphicData uri="http://schemas.openxmlformats.org/drawingml/2006/table">
            <a:tbl>
              <a:tblPr/>
              <a:tblGrid>
                <a:gridCol w="1260000">
                  <a:extLst>
                    <a:ext uri="{9D8B030D-6E8A-4147-A177-3AD203B41FA5}">
                      <a16:colId xmlns:a16="http://schemas.microsoft.com/office/drawing/2014/main" val="3641363282"/>
                    </a:ext>
                  </a:extLst>
                </a:gridCol>
                <a:gridCol w="1188720">
                  <a:extLst>
                    <a:ext uri="{9D8B030D-6E8A-4147-A177-3AD203B41FA5}">
                      <a16:colId xmlns:a16="http://schemas.microsoft.com/office/drawing/2014/main" val="1399146309"/>
                    </a:ext>
                  </a:extLst>
                </a:gridCol>
                <a:gridCol w="1088967">
                  <a:extLst>
                    <a:ext uri="{9D8B030D-6E8A-4147-A177-3AD203B41FA5}">
                      <a16:colId xmlns:a16="http://schemas.microsoft.com/office/drawing/2014/main" val="1474105335"/>
                    </a:ext>
                  </a:extLst>
                </a:gridCol>
                <a:gridCol w="1205345">
                  <a:extLst>
                    <a:ext uri="{9D8B030D-6E8A-4147-A177-3AD203B41FA5}">
                      <a16:colId xmlns:a16="http://schemas.microsoft.com/office/drawing/2014/main" val="2804770392"/>
                    </a:ext>
                  </a:extLst>
                </a:gridCol>
                <a:gridCol w="1122218">
                  <a:extLst>
                    <a:ext uri="{9D8B030D-6E8A-4147-A177-3AD203B41FA5}">
                      <a16:colId xmlns:a16="http://schemas.microsoft.com/office/drawing/2014/main" val="755566812"/>
                    </a:ext>
                  </a:extLst>
                </a:gridCol>
                <a:gridCol w="1205346">
                  <a:extLst>
                    <a:ext uri="{9D8B030D-6E8A-4147-A177-3AD203B41FA5}">
                      <a16:colId xmlns:a16="http://schemas.microsoft.com/office/drawing/2014/main" val="1069616439"/>
                    </a:ext>
                  </a:extLst>
                </a:gridCol>
                <a:gridCol w="1188000">
                  <a:extLst>
                    <a:ext uri="{9D8B030D-6E8A-4147-A177-3AD203B41FA5}">
                      <a16:colId xmlns:a16="http://schemas.microsoft.com/office/drawing/2014/main" val="3056659563"/>
                    </a:ext>
                  </a:extLst>
                </a:gridCol>
                <a:gridCol w="573577">
                  <a:extLst>
                    <a:ext uri="{9D8B030D-6E8A-4147-A177-3AD203B41FA5}">
                      <a16:colId xmlns:a16="http://schemas.microsoft.com/office/drawing/2014/main" val="3411186500"/>
                    </a:ext>
                  </a:extLst>
                </a:gridCol>
              </a:tblGrid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LD combined</a:t>
                      </a:r>
                      <a:r>
                        <a:rPr lang="en-US" sz="12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7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4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705597"/>
                  </a:ext>
                </a:extLst>
              </a:tr>
              <a:tr h="2600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3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3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  <a:cs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0191494"/>
                  </a:ext>
                </a:extLst>
              </a:tr>
            </a:tbl>
          </a:graphicData>
        </a:graphic>
      </p:graphicFrame>
      <p:cxnSp>
        <p:nvCxnSpPr>
          <p:cNvPr id="48" name="직선 연결선 47"/>
          <p:cNvCxnSpPr/>
          <p:nvPr/>
        </p:nvCxnSpPr>
        <p:spPr>
          <a:xfrm flipH="1">
            <a:off x="4061615" y="3316767"/>
            <a:ext cx="19934" cy="1830803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직선 연결선 48"/>
          <p:cNvCxnSpPr/>
          <p:nvPr/>
        </p:nvCxnSpPr>
        <p:spPr>
          <a:xfrm flipH="1">
            <a:off x="3412475" y="3316757"/>
            <a:ext cx="19934" cy="1830803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직선 연결선 49"/>
          <p:cNvCxnSpPr/>
          <p:nvPr/>
        </p:nvCxnSpPr>
        <p:spPr>
          <a:xfrm>
            <a:off x="6285802" y="2016931"/>
            <a:ext cx="616065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6246499" y="1671586"/>
            <a:ext cx="61606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5" name="표 6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5999179"/>
              </p:ext>
            </p:extLst>
          </p:nvPr>
        </p:nvGraphicFramePr>
        <p:xfrm>
          <a:off x="7049193" y="1460596"/>
          <a:ext cx="3060000" cy="7090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84000">
                  <a:extLst>
                    <a:ext uri="{9D8B030D-6E8A-4147-A177-3AD203B41FA5}">
                      <a16:colId xmlns:a16="http://schemas.microsoft.com/office/drawing/2014/main" val="4054309642"/>
                    </a:ext>
                  </a:extLst>
                </a:gridCol>
                <a:gridCol w="1476000">
                  <a:extLst>
                    <a:ext uri="{9D8B030D-6E8A-4147-A177-3AD203B41FA5}">
                      <a16:colId xmlns:a16="http://schemas.microsoft.com/office/drawing/2014/main" val="1883565153"/>
                    </a:ext>
                  </a:extLst>
                </a:gridCol>
              </a:tblGrid>
              <a:tr h="354510">
                <a:tc>
                  <a:txBody>
                    <a:bodyPr/>
                    <a:lstStyle/>
                    <a:p>
                      <a:r>
                        <a:rPr lang="en-US" altLang="ko-KR" sz="16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D combined RT</a:t>
                      </a:r>
                      <a:endParaRPr lang="ko-KR" altLang="en-US" sz="16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6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.8 (8.5-11.2)</a:t>
                      </a:r>
                      <a:endParaRPr lang="ko-KR" altLang="en-US" sz="16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458970"/>
                  </a:ext>
                </a:extLst>
              </a:tr>
              <a:tr h="35451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orafenib</a:t>
                      </a:r>
                      <a:endParaRPr lang="ko-KR" altLang="en-US" sz="16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6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2 (3.6-4.8)</a:t>
                      </a:r>
                      <a:endParaRPr lang="ko-KR" altLang="en-US" sz="16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1441797"/>
                  </a:ext>
                </a:extLst>
              </a:tr>
            </a:tbl>
          </a:graphicData>
        </a:graphic>
      </p:graphicFrame>
      <p:sp>
        <p:nvSpPr>
          <p:cNvPr id="66" name="TextBox 65"/>
          <p:cNvSpPr txBox="1"/>
          <p:nvPr/>
        </p:nvSpPr>
        <p:spPr>
          <a:xfrm>
            <a:off x="7049193" y="1106653"/>
            <a:ext cx="26128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Median OS, months (95% CI)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7049193" y="2169616"/>
            <a:ext cx="31854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Calibri" panose="020F0502020204030204" pitchFamily="34" charset="0"/>
                <a:cs typeface="Calibri" panose="020F0502020204030204" pitchFamily="34" charset="0"/>
              </a:rPr>
              <a:t>HR 0.59 (95% CI 0.50-0.70; </a:t>
            </a:r>
            <a:r>
              <a:rPr lang="en-US" altLang="ko-KR" sz="16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600" dirty="0">
                <a:latin typeface="Calibri" panose="020F0502020204030204" pitchFamily="34" charset="0"/>
                <a:cs typeface="Calibri" panose="020F0502020204030204" pitchFamily="34" charset="0"/>
              </a:rPr>
              <a:t>&lt;0.001)</a:t>
            </a:r>
            <a:endParaRPr lang="ko-KR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4009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595</Words>
  <Application>Microsoft Office PowerPoint</Application>
  <PresentationFormat>Widescreen</PresentationFormat>
  <Paragraphs>23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맑은 고딕</vt:lpstr>
      <vt:lpstr>Arial</vt:lpstr>
      <vt:lpstr>Calibri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V337M1WDS002</dc:creator>
  <cp:lastModifiedBy>MDPI</cp:lastModifiedBy>
  <cp:revision>5</cp:revision>
  <dcterms:created xsi:type="dcterms:W3CDTF">2023-01-27T06:27:08Z</dcterms:created>
  <dcterms:modified xsi:type="dcterms:W3CDTF">2023-06-13T04:10:12Z</dcterms:modified>
</cp:coreProperties>
</file>